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7" d="100"/>
          <a:sy n="107" d="100"/>
        </p:scale>
        <p:origin x="1651" y="8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0444D-C728-4E93-AFFC-11AF6A8E28A4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44A9E-47E0-4A13-9BC8-532119CCBF3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62887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0444D-C728-4E93-AFFC-11AF6A8E28A4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44A9E-47E0-4A13-9BC8-532119CCBF3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40851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0444D-C728-4E93-AFFC-11AF6A8E28A4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44A9E-47E0-4A13-9BC8-532119CCBF3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41772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0444D-C728-4E93-AFFC-11AF6A8E28A4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44A9E-47E0-4A13-9BC8-532119CCBF3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81216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0444D-C728-4E93-AFFC-11AF6A8E28A4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44A9E-47E0-4A13-9BC8-532119CCBF3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20216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0444D-C728-4E93-AFFC-11AF6A8E28A4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44A9E-47E0-4A13-9BC8-532119CCBF3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60906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0444D-C728-4E93-AFFC-11AF6A8E28A4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44A9E-47E0-4A13-9BC8-532119CCBF3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30869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0444D-C728-4E93-AFFC-11AF6A8E28A4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44A9E-47E0-4A13-9BC8-532119CCBF3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2223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0444D-C728-4E93-AFFC-11AF6A8E28A4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44A9E-47E0-4A13-9BC8-532119CCBF3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7099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0444D-C728-4E93-AFFC-11AF6A8E28A4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44A9E-47E0-4A13-9BC8-532119CCBF3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95316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0444D-C728-4E93-AFFC-11AF6A8E28A4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44A9E-47E0-4A13-9BC8-532119CCBF3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55317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50444D-C728-4E93-AFFC-11AF6A8E28A4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844A9E-47E0-4A13-9BC8-532119CCBF3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46855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27243" y="3276600"/>
            <a:ext cx="3414713" cy="1928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Textfeld 5"/>
          <p:cNvSpPr txBox="1"/>
          <p:nvPr/>
        </p:nvSpPr>
        <p:spPr>
          <a:xfrm>
            <a:off x="1295400" y="835223"/>
            <a:ext cx="1505540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4 weeks on diet</a:t>
            </a:r>
          </a:p>
        </p:txBody>
      </p:sp>
      <p:sp>
        <p:nvSpPr>
          <p:cNvPr id="7" name="Textfeld 6"/>
          <p:cNvSpPr txBox="1"/>
          <p:nvPr/>
        </p:nvSpPr>
        <p:spPr>
          <a:xfrm>
            <a:off x="5908126" y="835223"/>
            <a:ext cx="1604927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24 weeks on diet</a:t>
            </a:r>
          </a:p>
        </p:txBody>
      </p:sp>
      <p:pic>
        <p:nvPicPr>
          <p:cNvPr id="22" name="Picture 300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4824" y="1371600"/>
            <a:ext cx="3414713" cy="192166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3" name="Picture 301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27243" y="1371600"/>
            <a:ext cx="3414713" cy="192166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2" name="Textfeld 31">
            <a:extLst>
              <a:ext uri="{FF2B5EF4-FFF2-40B4-BE49-F238E27FC236}">
                <a16:creationId xmlns:a16="http://schemas.microsoft.com/office/drawing/2014/main" id="{0C52C18F-92FD-490F-9CAD-F9F34C81B949}"/>
              </a:ext>
            </a:extLst>
          </p:cNvPr>
          <p:cNvSpPr txBox="1"/>
          <p:nvPr/>
        </p:nvSpPr>
        <p:spPr>
          <a:xfrm>
            <a:off x="105822" y="1371600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feld 32">
            <a:extLst>
              <a:ext uri="{FF2B5EF4-FFF2-40B4-BE49-F238E27FC236}">
                <a16:creationId xmlns:a16="http://schemas.microsoft.com/office/drawing/2014/main" id="{BF8CE867-B5F3-4844-BAD3-0A2E2F0F6B9D}"/>
              </a:ext>
            </a:extLst>
          </p:cNvPr>
          <p:cNvSpPr txBox="1"/>
          <p:nvPr/>
        </p:nvSpPr>
        <p:spPr>
          <a:xfrm>
            <a:off x="4819907" y="1371600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feld 33">
            <a:extLst>
              <a:ext uri="{FF2B5EF4-FFF2-40B4-BE49-F238E27FC236}">
                <a16:creationId xmlns:a16="http://schemas.microsoft.com/office/drawing/2014/main" id="{DDFD0110-97E1-40EF-97C4-5FD061914E51}"/>
              </a:ext>
            </a:extLst>
          </p:cNvPr>
          <p:cNvSpPr txBox="1"/>
          <p:nvPr/>
        </p:nvSpPr>
        <p:spPr>
          <a:xfrm>
            <a:off x="105822" y="3288268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feld 36">
            <a:extLst>
              <a:ext uri="{FF2B5EF4-FFF2-40B4-BE49-F238E27FC236}">
                <a16:creationId xmlns:a16="http://schemas.microsoft.com/office/drawing/2014/main" id="{68F001B8-6449-45EE-BC75-4D9D789AF7D2}"/>
              </a:ext>
            </a:extLst>
          </p:cNvPr>
          <p:cNvSpPr txBox="1"/>
          <p:nvPr/>
        </p:nvSpPr>
        <p:spPr>
          <a:xfrm>
            <a:off x="4819907" y="3288268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feld 37">
            <a:extLst>
              <a:ext uri="{FF2B5EF4-FFF2-40B4-BE49-F238E27FC236}">
                <a16:creationId xmlns:a16="http://schemas.microsoft.com/office/drawing/2014/main" id="{1DD624BC-1E2B-4C1C-9D18-E37C30031D9A}"/>
              </a:ext>
            </a:extLst>
          </p:cNvPr>
          <p:cNvSpPr txBox="1"/>
          <p:nvPr/>
        </p:nvSpPr>
        <p:spPr>
          <a:xfrm>
            <a:off x="1" y="5867400"/>
            <a:ext cx="9144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7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elative concentrations of prostaglandin D2 (PGD2) and thromboxane B2 (TxB2) (expressed as fold changes relative to SC)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a/b)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nd relative gene expression of prostaglandin D2 synthase 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Ptgd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and thromboxane A synthase-1 (Tbxas1) (expressed as fold changes relative to SC)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c/d)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 the mouse cortex. Male C57BL6/J mice were fed either a standard chow diet (SC) or a high fat diet (HF) for 4 weeks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a, c)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nd 24 weeks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b</a:t>
            </a:r>
            <a:r>
              <a:rPr lang="en-US" sz="1200" smtClean="0">
                <a:latin typeface="Arial" panose="020B0604020202020204" pitchFamily="34" charset="0"/>
                <a:cs typeface="Arial" panose="020B0604020202020204" pitchFamily="34" charset="0"/>
              </a:rPr>
              <a:t>, d)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nd cortex was subjected for analysis. Statistics: Student’s t test p&lt;0.01**.</a:t>
            </a: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4824" y="3276600"/>
            <a:ext cx="3414713" cy="1928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" name="Textfeld 7"/>
          <p:cNvSpPr txBox="1"/>
          <p:nvPr/>
        </p:nvSpPr>
        <p:spPr>
          <a:xfrm>
            <a:off x="2438400" y="1524000"/>
            <a:ext cx="3642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</p:spTree>
    <p:extLst>
      <p:ext uri="{BB962C8B-B14F-4D97-AF65-F5344CB8AC3E}">
        <p14:creationId xmlns:p14="http://schemas.microsoft.com/office/powerpoint/2010/main" val="3939537775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8</Words>
  <Application>Microsoft Office PowerPoint</Application>
  <PresentationFormat>Bildschirmpräsentation (4:3)</PresentationFormat>
  <Paragraphs>8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4" baseType="lpstr">
      <vt:lpstr>Arial</vt:lpstr>
      <vt:lpstr>Calibri</vt:lpstr>
      <vt:lpstr>Larissa</vt:lpstr>
      <vt:lpstr>PowerPoint-Präsentation</vt:lpstr>
    </vt:vector>
  </TitlesOfParts>
  <Company>Universitätsklinikum Leipzig Aö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dlen Reinicke</dc:creator>
  <cp:lastModifiedBy>Reinicke, Madlen</cp:lastModifiedBy>
  <cp:revision>47</cp:revision>
  <cp:lastPrinted>2020-06-22T08:42:55Z</cp:lastPrinted>
  <dcterms:created xsi:type="dcterms:W3CDTF">2020-04-21T14:10:58Z</dcterms:created>
  <dcterms:modified xsi:type="dcterms:W3CDTF">2021-09-21T13:02:56Z</dcterms:modified>
</cp:coreProperties>
</file>